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50" d="100"/>
          <a:sy n="50" d="100"/>
        </p:scale>
        <p:origin x="1218" y="5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53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852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770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439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0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841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028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898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685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361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05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DA0BB-A13D-426C-8C0F-A0A96C45D859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6E6004-032A-4B8D-99E9-AA85AAF019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970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9390343"/>
              </p:ext>
            </p:extLst>
          </p:nvPr>
        </p:nvGraphicFramePr>
        <p:xfrm>
          <a:off x="1965325" y="1353324"/>
          <a:ext cx="8484061" cy="501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Acrobat Document" r:id="rId3" imgW="10963005" imgH="6486356" progId="AcroExch.Document.11">
                  <p:embed/>
                </p:oleObj>
              </mc:Choice>
              <mc:Fallback>
                <p:oleObj name="Acrobat Document" r:id="rId3" imgW="10963005" imgH="6486356" progId="AcroExch.Documen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65325" y="1353324"/>
                        <a:ext cx="8484061" cy="501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90600" y="429994"/>
            <a:ext cx="9982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: Figure S1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curve of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ishmani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(1ng) served as a positive control in the reaction. Negative samples were defined by the absence of fluorescent signals above the threshold within 35 cycles.</a:t>
            </a:r>
          </a:p>
        </p:txBody>
      </p:sp>
    </p:spTree>
    <p:extLst>
      <p:ext uri="{BB962C8B-B14F-4D97-AF65-F5344CB8AC3E}">
        <p14:creationId xmlns:p14="http://schemas.microsoft.com/office/powerpoint/2010/main" val="1876175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Adobe Acrobat Document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3</cp:revision>
  <dcterms:created xsi:type="dcterms:W3CDTF">2021-05-07T22:17:55Z</dcterms:created>
  <dcterms:modified xsi:type="dcterms:W3CDTF">2021-05-07T22:24:24Z</dcterms:modified>
</cp:coreProperties>
</file>